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94626"/>
  </p:normalViewPr>
  <p:slideViewPr>
    <p:cSldViewPr snapToGrid="0">
      <p:cViewPr varScale="1">
        <p:scale>
          <a:sx n="100" d="100"/>
          <a:sy n="100" d="100"/>
        </p:scale>
        <p:origin x="9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41EA4A-9654-09A1-847F-50E6A4A684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E08C093-2546-9BA3-BB17-11926293F5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7EF434-A748-A734-A783-1255F1F8B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B8C76E-1EF5-672D-86B5-FC09FBD6D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FCD01A-CA3F-21A5-3E65-CE99B97D9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485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464BB3-4A8A-2E4B-999D-658C28C43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DE1F28-4ECC-4F81-9DA6-4BF421EFEC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5E0F71-56C1-6FC6-D644-C159B3242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E9FFFA-D110-79F6-0BB1-BD92B5695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40E82D-C73C-BD93-129D-0358BABDF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0781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ACF1F4-5DB0-DE86-7275-3169E261E3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645FF1-CBC3-BBC5-FFFE-E61E8BB3A1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3ED52E-DF25-AAEF-0BF1-1EE168826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3CA725-19A3-8169-3F48-95037E5F1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669299-3664-07B5-6956-35D779B17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7571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B57BB4-9002-8858-953A-83611ABE72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A552F9-DF71-85D0-E1D5-E09DE1CD77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1328F2-9988-9C6B-D740-08C2359C0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D62E26-F842-239C-7842-93AFF46CE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044579-C7E8-202D-1176-532A1A007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0686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376C3C-2116-B461-1699-66DA664AA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5183F8-19C9-BF9F-6DEF-01149ECC24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C269B2-C46F-3A01-F6D2-0C0837057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C7758F-D230-2CD8-7982-79D270B9F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0C7BE-413D-7CA2-168A-2BD535534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2018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EBA2F4-CBE8-7077-0C35-1CAE126B39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E0A0B7-BF0B-065A-9F08-7BE5369C70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E66839-933A-F2F4-389A-070A17D3B9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8E16AC-07F7-DCAA-8C31-45A25D187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9DFC73-82E6-ED5F-E3C4-BE30EB7A3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4C43A0-24D3-596D-D9C8-8A5A690D1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6661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83E90B-1CF3-06A0-C390-58192C1CDB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A00236-E01C-67E3-EE23-DE1FB40E9A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1491BD-0BF3-E414-ACD0-8C01DF3D9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203DBC-5A55-EC94-FAFA-90B9126897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E5DB7A3-4175-B55B-6935-5CDBB735EC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D69D97-1858-9B9E-8DF0-AB5E14928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E459B6-3311-3F3A-6777-32DB8F8B4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0BA5CFF-6672-7831-A8B6-521DA0A56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5150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5D716A-CD70-6FC0-B9A1-010F6A4A80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E318D5-3BCF-EB64-BFED-1F4B622AD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981D7A-DC9E-3C00-5FE6-00FD13EF6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3E62E8-339E-6FEF-3B74-3B0016563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8878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E6D1C52-7BB2-EC8A-19F5-F2C6553FA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A489A6-BC5C-3C0B-3558-EBAACFEA5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27AFC1-4C9F-7852-817C-751E27690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706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F378C9-35AE-E974-CAC5-2C57B67D7A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114363-4563-75CD-5E36-357CA5A48D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7CC133-D953-7422-E663-A194FE0D68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BBC643-3C08-4F78-E220-03170C00E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C5C947-317D-3FC8-00A7-A00AE9D66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09A43F-FAAA-F99B-52B9-B33C74622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9758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D1794-1786-6AEC-AD80-9951953B9C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2B05BB-A01D-F603-A622-6EFD66FA12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514674-F974-6274-314B-C1E6530AC6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82D1E6-9D3D-F180-C298-A3B702E90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93E17B-414B-D6ED-7D3B-A8E78C251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D83630-B6B4-337C-5CAC-5068E358F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5433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938909-9295-820D-0DB5-406BE447B0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5666AF-D5E9-9FA6-BD96-4B28780BF7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EDDC0D-E2F3-7A10-EEE9-7FEFBCD302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EAE1B0-6E67-4DD0-A7C2-58202A901EFF}" type="datetimeFigureOut">
              <a:rPr lang="en-GB" smtClean="0"/>
              <a:t>20/01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6F7A8A-17FA-3BA0-F1E0-A383C1E4EB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88DABA-1C18-A77A-9E56-3166CAC147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34CB4E-CEE6-49A9-ADDE-33413F798A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240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creen Recording 3">
            <a:hlinkClick r:id="" action="ppaction://media"/>
            <a:extLst>
              <a:ext uri="{FF2B5EF4-FFF2-40B4-BE49-F238E27FC236}">
                <a16:creationId xmlns:a16="http://schemas.microsoft.com/office/drawing/2014/main" id="{4A140EC4-22CF-F041-8BF6-16DE3931D0D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352800" y="371475"/>
            <a:ext cx="5486400" cy="61150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FEAD11D-01BC-60E0-05DD-240C75C9399F}"/>
              </a:ext>
            </a:extLst>
          </p:cNvPr>
          <p:cNvSpPr txBox="1"/>
          <p:nvPr/>
        </p:nvSpPr>
        <p:spPr>
          <a:xfrm>
            <a:off x="9042400" y="723900"/>
            <a:ext cx="180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tart of case</a:t>
            </a:r>
          </a:p>
        </p:txBody>
      </p:sp>
    </p:spTree>
    <p:extLst>
      <p:ext uri="{BB962C8B-B14F-4D97-AF65-F5344CB8AC3E}">
        <p14:creationId xmlns:p14="http://schemas.microsoft.com/office/powerpoint/2010/main" val="42019582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800"/>
    </mc:Choice>
    <mc:Fallback xmlns="">
      <p:transition spd="slow" advTm="480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8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creen Recording 1">
            <a:hlinkClick r:id="" action="ppaction://media"/>
            <a:extLst>
              <a:ext uri="{FF2B5EF4-FFF2-40B4-BE49-F238E27FC236}">
                <a16:creationId xmlns:a16="http://schemas.microsoft.com/office/drawing/2014/main" id="{7ED98979-2C50-9352-2DB1-332C91A95C6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609975" y="390525"/>
            <a:ext cx="4972050" cy="607695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B456EEB-0752-B9DC-8CCB-44A2EA53B20E}"/>
              </a:ext>
            </a:extLst>
          </p:cNvPr>
          <p:cNvSpPr txBox="1"/>
          <p:nvPr/>
        </p:nvSpPr>
        <p:spPr>
          <a:xfrm>
            <a:off x="9042400" y="723900"/>
            <a:ext cx="2362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ydrophilic Terumo wire in main pulmonary artery</a:t>
            </a:r>
          </a:p>
        </p:txBody>
      </p:sp>
    </p:spTree>
    <p:extLst>
      <p:ext uri="{BB962C8B-B14F-4D97-AF65-F5344CB8AC3E}">
        <p14:creationId xmlns:p14="http://schemas.microsoft.com/office/powerpoint/2010/main" val="15659021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5700"/>
    </mc:Choice>
    <mc:Fallback xmlns="">
      <p:transition spd="slow" advTm="570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7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creen Recording 1">
            <a:hlinkClick r:id="" action="ppaction://media"/>
            <a:extLst>
              <a:ext uri="{FF2B5EF4-FFF2-40B4-BE49-F238E27FC236}">
                <a16:creationId xmlns:a16="http://schemas.microsoft.com/office/drawing/2014/main" id="{5017696A-FFB6-4176-8ACB-7199EBEDB78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524250" y="447675"/>
            <a:ext cx="5143500" cy="596265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6F2E933-7B72-A9E7-CE83-542BAE8D6497}"/>
              </a:ext>
            </a:extLst>
          </p:cNvPr>
          <p:cNvSpPr txBox="1"/>
          <p:nvPr/>
        </p:nvSpPr>
        <p:spPr>
          <a:xfrm>
            <a:off x="9042400" y="723900"/>
            <a:ext cx="220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ridge balloon inflation</a:t>
            </a:r>
          </a:p>
        </p:txBody>
      </p:sp>
    </p:spTree>
    <p:extLst>
      <p:ext uri="{BB962C8B-B14F-4D97-AF65-F5344CB8AC3E}">
        <p14:creationId xmlns:p14="http://schemas.microsoft.com/office/powerpoint/2010/main" val="4216370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9200"/>
    </mc:Choice>
    <mc:Fallback xmlns="">
      <p:transition spd="slow" advTm="920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2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creen Recording 3">
            <a:hlinkClick r:id="" action="ppaction://media"/>
            <a:extLst>
              <a:ext uri="{FF2B5EF4-FFF2-40B4-BE49-F238E27FC236}">
                <a16:creationId xmlns:a16="http://schemas.microsoft.com/office/drawing/2014/main" id="{C3DC9E43-22C8-ED23-3791-261DF89A4F0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524250" y="447675"/>
            <a:ext cx="5143500" cy="59626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B472A19-6645-EB80-8D2E-B48A1D764084}"/>
              </a:ext>
            </a:extLst>
          </p:cNvPr>
          <p:cNvSpPr txBox="1"/>
          <p:nvPr/>
        </p:nvSpPr>
        <p:spPr>
          <a:xfrm>
            <a:off x="9042400" y="723900"/>
            <a:ext cx="21463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14Fr laser sheath advanced over RV lead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327157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600"/>
    </mc:Choice>
    <mc:Fallback xmlns="">
      <p:transition spd="slow" advTm="460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5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creen Recording 1">
            <a:hlinkClick r:id="" action="ppaction://media"/>
            <a:extLst>
              <a:ext uri="{FF2B5EF4-FFF2-40B4-BE49-F238E27FC236}">
                <a16:creationId xmlns:a16="http://schemas.microsoft.com/office/drawing/2014/main" id="{9B0A7605-C219-9B82-A88A-85C8523FBC2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648075" y="47625"/>
            <a:ext cx="4895850" cy="67627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8272BDF-E931-ACE0-2455-34C468C482F3}"/>
              </a:ext>
            </a:extLst>
          </p:cNvPr>
          <p:cNvSpPr txBox="1"/>
          <p:nvPr/>
        </p:nvSpPr>
        <p:spPr>
          <a:xfrm>
            <a:off x="8750300" y="767834"/>
            <a:ext cx="30480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13Fr rotating mechanical sheath subsequently deployed with successful lead extraction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218725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8400"/>
    </mc:Choice>
    <mc:Fallback xmlns="">
      <p:transition spd="slow" advTm="840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4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0</Words>
  <Application>Microsoft Macintosh PowerPoint</Application>
  <PresentationFormat>Widescreen</PresentationFormat>
  <Paragraphs>5</Paragraphs>
  <Slides>5</Slides>
  <Notes>0</Notes>
  <HiddenSlides>0</HiddenSlides>
  <MMClips>5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Guy's and St. Thomas' NHS Foundation Tru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edict McDonaugh</dc:creator>
  <cp:lastModifiedBy>GANATRA, Rea (GUY'S AND ST THOMAS' NHS FOUNDATION TRUST)</cp:lastModifiedBy>
  <cp:revision>2</cp:revision>
  <dcterms:created xsi:type="dcterms:W3CDTF">2026-01-20T18:04:17Z</dcterms:created>
  <dcterms:modified xsi:type="dcterms:W3CDTF">2026-01-20T21:35:34Z</dcterms:modified>
</cp:coreProperties>
</file>